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624138" y="1162050"/>
            <a:ext cx="17621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3AA957-8384-EA41-99C1-28AD808CE5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0101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25C825C4-9B67-0BC0-BB57-8A5CDB9FEE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629" y="438866"/>
            <a:ext cx="5788742" cy="680942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7A72DE1-00A8-29D8-B82D-8EC327681A8F}"/>
              </a:ext>
            </a:extLst>
          </p:cNvPr>
          <p:cNvSpPr txBox="1"/>
          <p:nvPr/>
        </p:nvSpPr>
        <p:spPr>
          <a:xfrm>
            <a:off x="877314" y="2260865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E5610E-8A0D-4A43-ECF5-1634C9FD0367}"/>
              </a:ext>
            </a:extLst>
          </p:cNvPr>
          <p:cNvSpPr txBox="1"/>
          <p:nvPr/>
        </p:nvSpPr>
        <p:spPr>
          <a:xfrm>
            <a:off x="995447" y="2490726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13C57B-E162-DE80-2530-B946AB56DB63}"/>
              </a:ext>
            </a:extLst>
          </p:cNvPr>
          <p:cNvSpPr txBox="1"/>
          <p:nvPr/>
        </p:nvSpPr>
        <p:spPr>
          <a:xfrm>
            <a:off x="3022705" y="2279188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3F39A3-1A45-E567-DC68-EB9FA8F394A9}"/>
              </a:ext>
            </a:extLst>
          </p:cNvPr>
          <p:cNvSpPr txBox="1"/>
          <p:nvPr/>
        </p:nvSpPr>
        <p:spPr>
          <a:xfrm>
            <a:off x="4800072" y="2322880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70EDE3-E08E-D54E-8ED3-692E30448276}"/>
              </a:ext>
            </a:extLst>
          </p:cNvPr>
          <p:cNvSpPr txBox="1"/>
          <p:nvPr/>
        </p:nvSpPr>
        <p:spPr>
          <a:xfrm>
            <a:off x="770124" y="4639646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4BBB821-8A06-C615-136A-BE59A7F85054}"/>
              </a:ext>
            </a:extLst>
          </p:cNvPr>
          <p:cNvSpPr txBox="1"/>
          <p:nvPr/>
        </p:nvSpPr>
        <p:spPr>
          <a:xfrm>
            <a:off x="2990027" y="4763737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4AB747-46E4-F790-C500-8B5B37D639BF}"/>
              </a:ext>
            </a:extLst>
          </p:cNvPr>
          <p:cNvSpPr txBox="1"/>
          <p:nvPr/>
        </p:nvSpPr>
        <p:spPr>
          <a:xfrm>
            <a:off x="707914" y="6921926"/>
            <a:ext cx="877942" cy="4265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35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82F45E-B217-A80E-69C8-0CD9AA151D59}"/>
              </a:ext>
            </a:extLst>
          </p:cNvPr>
          <p:cNvSpPr txBox="1"/>
          <p:nvPr/>
        </p:nvSpPr>
        <p:spPr>
          <a:xfrm>
            <a:off x="99496" y="7240168"/>
            <a:ext cx="6485723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068705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5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low cytometry gating strategy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Immunophenotyping was performed on single cell suspensions of TC32 Ewing sarcoma tumors developed in hu-CD34+ mice. Representative plots to demonstrate the gating strategy used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o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efine immune cell sub-populations are shown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6692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4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1:38Z</dcterms:modified>
</cp:coreProperties>
</file>